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0A25116-1DF2-47F5-B020-46B8F0759CBF}" v="2" dt="2025-01-17T13:48:37.83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87" d="100"/>
          <a:sy n="87" d="100"/>
        </p:scale>
        <p:origin x="520" y="2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aniel Kerruish" userId="eafcbf4d4b911c7b" providerId="LiveId" clId="{20A25116-1DF2-47F5-B020-46B8F0759CBF}"/>
    <pc:docChg chg="modSld">
      <pc:chgData name="Daniel Kerruish" userId="eafcbf4d4b911c7b" providerId="LiveId" clId="{20A25116-1DF2-47F5-B020-46B8F0759CBF}" dt="2025-01-17T13:48:55.036" v="11" actId="20577"/>
      <pc:docMkLst>
        <pc:docMk/>
      </pc:docMkLst>
      <pc:sldChg chg="addSp modSp mod">
        <pc:chgData name="Daniel Kerruish" userId="eafcbf4d4b911c7b" providerId="LiveId" clId="{20A25116-1DF2-47F5-B020-46B8F0759CBF}" dt="2025-01-17T13:48:55.036" v="11" actId="20577"/>
        <pc:sldMkLst>
          <pc:docMk/>
          <pc:sldMk cId="320936657" sldId="256"/>
        </pc:sldMkLst>
        <pc:spChg chg="add mod">
          <ac:chgData name="Daniel Kerruish" userId="eafcbf4d4b911c7b" providerId="LiveId" clId="{20A25116-1DF2-47F5-B020-46B8F0759CBF}" dt="2025-01-17T13:48:33.555" v="3" actId="14100"/>
          <ac:spMkLst>
            <pc:docMk/>
            <pc:sldMk cId="320936657" sldId="256"/>
            <ac:spMk id="2" creationId="{0E4032C8-C43A-BA1B-953D-6A23D791DB4D}"/>
          </ac:spMkLst>
        </pc:spChg>
        <pc:spChg chg="add mod">
          <ac:chgData name="Daniel Kerruish" userId="eafcbf4d4b911c7b" providerId="LiveId" clId="{20A25116-1DF2-47F5-B020-46B8F0759CBF}" dt="2025-01-17T13:48:45.997" v="6" actId="20577"/>
          <ac:spMkLst>
            <pc:docMk/>
            <pc:sldMk cId="320936657" sldId="256"/>
            <ac:spMk id="3" creationId="{C5CBECC3-8D74-F062-663C-2BA1E358D6C7}"/>
          </ac:spMkLst>
        </pc:spChg>
        <pc:spChg chg="mod">
          <ac:chgData name="Daniel Kerruish" userId="eafcbf4d4b911c7b" providerId="LiveId" clId="{20A25116-1DF2-47F5-B020-46B8F0759CBF}" dt="2025-01-17T13:48:55.036" v="11" actId="20577"/>
          <ac:spMkLst>
            <pc:docMk/>
            <pc:sldMk cId="320936657" sldId="256"/>
            <ac:spMk id="7" creationId="{D4FD5B7D-DEC8-80CD-5FD7-B9CE7FF2762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1F8248-767C-8B76-2067-50983E3EBE7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84DE438-1663-6955-7F60-44F59CD97E3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FC0955-3DD2-4B71-0E23-5E5001AC6E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8BDB6-9AE1-45B7-A1B9-2265BAE44BC2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535880E-E218-655A-A7C8-AF1901294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4E26A3-EDF7-400D-C7E9-93CF058409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592BC-5CD0-42D5-8DD9-A241D9EC664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4125312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817198-B8DC-B2A4-BCED-0E7C24B2AA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A5FB84-1D54-6F2E-940C-3DC35C5FC51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58D6EC9-F82F-31A1-616A-5C5F4EC31A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8BDB6-9AE1-45B7-A1B9-2265BAE44BC2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C4BE8F-E535-CD8E-1AE6-B12EA53A98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601B74-51CA-121C-FB34-734EB4CEDB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592BC-5CD0-42D5-8DD9-A241D9EC664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419443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D4B5027-FF4F-787F-8B3B-41D244B6FD8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C7F7F0A-49D5-5ABE-6C3D-148ED56A33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033DD6-00E3-FF05-45C7-5C7D16A461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8BDB6-9AE1-45B7-A1B9-2265BAE44BC2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FC8EC3-0758-3381-0807-5365E86D35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7B2EC2-ED03-F94C-126F-CF110DFCD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592BC-5CD0-42D5-8DD9-A241D9EC664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5885296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3445D2-05AA-B743-AC0F-B60F01DB1C2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62B6F1-4884-3E91-8A64-44668F906A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0C18F9-27E9-7951-CDF4-BE5555E5D5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8BDB6-9AE1-45B7-A1B9-2265BAE44BC2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B11789-1059-2AA3-46A7-0D44914D031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13923E-85B6-0F08-DD2B-ED034666CC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592BC-5CD0-42D5-8DD9-A241D9EC664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6867448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6DA675-A3A7-94E4-B203-9EC5D8157A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0F2F663-0CA9-8AC1-D28C-55D08342E9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BF912CF-855D-69C6-F13C-84A264D548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8BDB6-9AE1-45B7-A1B9-2265BAE44BC2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4B34894-167F-CCF8-B551-92914735B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2AB1E8-BE0F-72B2-04C0-CC80EBC33C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592BC-5CD0-42D5-8DD9-A241D9EC664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4758009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5193EC-C2EB-C17F-D558-AA36E161B2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8608A1-185C-FE95-616F-F8E9E971AD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4C42A2C-2A29-1689-7635-CD119DA2F9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8D32BD4-55F9-79CA-B6CD-C2A9DF6B59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8BDB6-9AE1-45B7-A1B9-2265BAE44BC2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E044FB9-E8B3-18F5-F800-DD354E43A0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32A8BA6-A7C0-3D5A-1E50-61D70AA16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592BC-5CD0-42D5-8DD9-A241D9EC664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1799910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C37034B-3459-DE82-7156-991936F6D8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6533C94-8C82-61D9-1119-DF509929AFF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BD9CB5-E091-7066-DE35-058B0C974B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F6CB67-5986-BE05-9B1F-7D668FD608E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539E670-2EB8-61E9-DC45-8A45B7A70D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C7471EB-5164-787E-9FA6-7EDCB5541F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8BDB6-9AE1-45B7-A1B9-2265BAE44BC2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6615455-69A7-1C2F-C4C6-8AF0DFB99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1B8113A-EAD1-7103-B00F-6AEBB56C5A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592BC-5CD0-42D5-8DD9-A241D9EC664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746854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B4EA96-E146-C7C0-C6B7-7D63E34C588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A945904-B164-649D-18F9-43A95D6E3D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8BDB6-9AE1-45B7-A1B9-2265BAE44BC2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B7680F-C5C8-0FCE-6DD3-55751E4D31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F630447-89FA-1558-5E2D-BA492F2C5B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592BC-5CD0-42D5-8DD9-A241D9EC664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30461934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362D220-1A0E-0F9C-3AE2-2881C85608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8BDB6-9AE1-45B7-A1B9-2265BAE44BC2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E593499-3D73-CA54-5C30-DAE13E771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572207A-6CE2-228C-DA6D-ACB27BBD74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592BC-5CD0-42D5-8DD9-A241D9EC664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8711539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65AE6F-0C85-6F35-22C2-520C0BD6732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13CB1E-5728-D3B1-AE27-62B6F837FB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C3C1A54-9524-DC7F-286C-00179982F25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B200CC3-F13D-481D-F2E4-B7E65865D9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8BDB6-9AE1-45B7-A1B9-2265BAE44BC2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B8A0D6-B67A-8A4E-8F4B-A7697D4B28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0B64362-4148-B67E-49EB-BE5A7A0691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592BC-5CD0-42D5-8DD9-A241D9EC664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5655367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D19681-EB75-17BC-2A68-734EAABD0A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8208B20-6E78-A1E5-2A8F-C6D80E55325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BE3C2A4-1AD0-CEC4-D855-DBEC5E6F75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29B2030-2064-A0C9-8F6E-5802059733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48BDB6-9AE1-45B7-A1B9-2265BAE44BC2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181F73B-F6B9-D91D-12E7-7729DDB8B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21FB65-A001-F668-FE5F-E646AE45F9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1592BC-5CD0-42D5-8DD9-A241D9EC664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20405767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187EADA-F544-41C8-7E48-A711E97222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7A1E17C-4A1A-9005-739D-988405616B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EDE9804-7C89-870B-8132-5C77548A97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E48BDB6-9AE1-45B7-A1B9-2265BAE44BC2}" type="datetimeFigureOut">
              <a:rPr lang="en-IE" smtClean="0"/>
              <a:t>17/01/2025</a:t>
            </a:fld>
            <a:endParaRPr lang="en-I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7C4C75-0F50-E8BD-E456-9C35ED3520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I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27F1D3-D6B1-1B0F-6319-41C406A37A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41592BC-5CD0-42D5-8DD9-A241D9EC664D}" type="slidenum">
              <a:rPr lang="en-IE" smtClean="0"/>
              <a:t>‹#›</a:t>
            </a:fld>
            <a:endParaRPr lang="en-IE"/>
          </a:p>
        </p:txBody>
      </p:sp>
    </p:spTree>
    <p:extLst>
      <p:ext uri="{BB962C8B-B14F-4D97-AF65-F5344CB8AC3E}">
        <p14:creationId xmlns:p14="http://schemas.microsoft.com/office/powerpoint/2010/main" val="1070274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4613C4A-8777-B900-E4FA-BB09105D9E7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01914" y="1036440"/>
            <a:ext cx="4504031" cy="2935464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8F8DFE7A-9D89-5B35-C674-11A99EA2DE6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40867" y="1215970"/>
            <a:ext cx="5849219" cy="267166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D4FD5B7D-DEC8-80CD-5FD7-B9CE7FF27620}"/>
              </a:ext>
            </a:extLst>
          </p:cNvPr>
          <p:cNvSpPr txBox="1"/>
          <p:nvPr/>
        </p:nvSpPr>
        <p:spPr>
          <a:xfrm>
            <a:off x="206827" y="4344232"/>
            <a:ext cx="11582401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sz="1800" b="0" i="0" u="none" strike="noStrike" baseline="0" dirty="0">
                <a:latin typeface="CIDFont+F2"/>
              </a:rPr>
              <a:t>Supplementary Figure 1: Representative Agilent 2100 Bioanalyzer gel of the historical Irish brewing yeast (A.), with </a:t>
            </a:r>
            <a:r>
              <a:rPr lang="en-IE" dirty="0">
                <a:latin typeface="fon3"/>
              </a:rPr>
              <a:t>e</a:t>
            </a:r>
            <a:r>
              <a:rPr lang="en-IE" sz="1800" b="0" i="0" u="none" strike="noStrike" baseline="0" dirty="0">
                <a:latin typeface="fon3"/>
              </a:rPr>
              <a:t>lectropherogram </a:t>
            </a:r>
            <a:r>
              <a:rPr lang="en-IE" sz="1800" b="0" i="0" u="none" strike="noStrike" baseline="0">
                <a:latin typeface="fon3"/>
              </a:rPr>
              <a:t>summary (B.) </a:t>
            </a:r>
            <a:r>
              <a:rPr lang="en-IE" sz="1800" b="0" i="0" u="none" strike="noStrike" baseline="0" dirty="0">
                <a:latin typeface="fon3"/>
              </a:rPr>
              <a:t>of </a:t>
            </a:r>
            <a:r>
              <a:rPr lang="en-US" sz="1800" b="0" i="0" u="none" strike="noStrike" baseline="0" dirty="0">
                <a:latin typeface="CIDFont+F2"/>
              </a:rPr>
              <a:t>PCR products of the </a:t>
            </a:r>
            <a:r>
              <a:rPr lang="en-US" sz="1800" b="0" i="0" u="none" strike="noStrike" baseline="0" dirty="0" err="1">
                <a:latin typeface="CIDFont+F2"/>
              </a:rPr>
              <a:t>interdelta</a:t>
            </a:r>
            <a:r>
              <a:rPr lang="en-US" dirty="0">
                <a:latin typeface="CIDFont+F2"/>
              </a:rPr>
              <a:t> </a:t>
            </a:r>
            <a:r>
              <a:rPr lang="en-US" sz="1800" b="0" i="0" u="none" strike="noStrike" baseline="0" dirty="0">
                <a:latin typeface="CIDFont+F2"/>
              </a:rPr>
              <a:t>specific primers δ2/ δ 12 (</a:t>
            </a:r>
            <a:r>
              <a:rPr lang="en-US" sz="1800" b="0" i="0" u="none" strike="noStrike" baseline="0" dirty="0" err="1">
                <a:latin typeface="CIDFont+F2"/>
              </a:rPr>
              <a:t>Legras</a:t>
            </a:r>
            <a:r>
              <a:rPr lang="en-US" sz="1800" b="0" i="0" u="none" strike="noStrike" baseline="0" dirty="0">
                <a:latin typeface="CIDFont+F2"/>
              </a:rPr>
              <a:t> and Karst 2003). PCRs were conducted on typical and atypical historical Irish yeast morphology as observed </a:t>
            </a:r>
            <a:r>
              <a:rPr lang="en-IE" sz="1800" b="0" i="0" u="none" strike="noStrike" baseline="0" dirty="0">
                <a:latin typeface="CIDFont+F2"/>
              </a:rPr>
              <a:t>through Giant Colony Morphology. </a:t>
            </a:r>
            <a:r>
              <a:rPr lang="en-IE" sz="1800" b="0" i="0" u="none" strike="noStrike" baseline="0" dirty="0">
                <a:latin typeface="fon3"/>
              </a:rPr>
              <a:t>Lane L indicates ladder with  Cherry yeasts in lanes 1-3, Perry lanes 4-6, </a:t>
            </a:r>
            <a:r>
              <a:rPr lang="en-IE" sz="1800" b="0" i="0" u="none" strike="noStrike" baseline="0" dirty="0" err="1">
                <a:latin typeface="fon3"/>
              </a:rPr>
              <a:t>Macardles</a:t>
            </a:r>
            <a:r>
              <a:rPr lang="en-IE" sz="1800" b="0" i="0" u="none" strike="noStrike" baseline="0" dirty="0">
                <a:latin typeface="fon3"/>
              </a:rPr>
              <a:t> 1965 lanes 7-9 and   </a:t>
            </a:r>
            <a:r>
              <a:rPr lang="en-IE" dirty="0" err="1">
                <a:latin typeface="fon3"/>
              </a:rPr>
              <a:t>M</a:t>
            </a:r>
            <a:r>
              <a:rPr lang="en-IE" sz="1800" b="0" i="0" u="none" strike="noStrike" baseline="0" dirty="0" err="1">
                <a:latin typeface="fon3"/>
              </a:rPr>
              <a:t>acardles</a:t>
            </a:r>
            <a:r>
              <a:rPr lang="en-IE" sz="1800" b="0" i="0" u="none" strike="noStrike" baseline="0" dirty="0">
                <a:latin typeface="fon3"/>
              </a:rPr>
              <a:t> 1993 lanes 10 and 11. </a:t>
            </a:r>
            <a:r>
              <a:rPr lang="en-US" sz="1800" b="0" i="0" u="none" strike="noStrike" baseline="0" dirty="0">
                <a:latin typeface="CIDFont+F2"/>
              </a:rPr>
              <a:t> Hierarchical clustering analysis of PCR products (determined using </a:t>
            </a:r>
            <a:r>
              <a:rPr lang="en-US" sz="1800" b="0" i="0" u="none" strike="noStrike" baseline="0" dirty="0" err="1">
                <a:latin typeface="CIDFont+F2"/>
              </a:rPr>
              <a:t>Bioanaylzer</a:t>
            </a:r>
            <a:r>
              <a:rPr lang="en-US" sz="1800" b="0" i="0" u="none" strike="noStrike" baseline="0" dirty="0">
                <a:latin typeface="CIDFont+F2"/>
              </a:rPr>
              <a:t> 2.0 DNA chips) of the </a:t>
            </a:r>
            <a:r>
              <a:rPr lang="en-US" sz="1800" b="0" i="0" u="none" strike="noStrike" baseline="0" dirty="0" err="1">
                <a:latin typeface="CIDFont+F2"/>
              </a:rPr>
              <a:t>interdelta</a:t>
            </a:r>
            <a:r>
              <a:rPr lang="en-US" dirty="0">
                <a:latin typeface="CIDFont+F2"/>
              </a:rPr>
              <a:t> </a:t>
            </a:r>
            <a:r>
              <a:rPr lang="en-US" sz="1800" b="0" i="0" u="none" strike="noStrike" baseline="0" dirty="0">
                <a:latin typeface="CIDFont+F2"/>
              </a:rPr>
              <a:t>specific primers δ2/ δ 12 (</a:t>
            </a:r>
            <a:r>
              <a:rPr lang="en-US" sz="1800" b="0" i="0" u="none" strike="noStrike" baseline="0" dirty="0" err="1">
                <a:latin typeface="CIDFont+F2"/>
              </a:rPr>
              <a:t>Legras</a:t>
            </a:r>
            <a:r>
              <a:rPr lang="en-US" sz="1800" b="0" i="0" u="none" strike="noStrike" baseline="0" dirty="0">
                <a:latin typeface="CIDFont+F2"/>
              </a:rPr>
              <a:t> and </a:t>
            </a:r>
            <a:r>
              <a:rPr lang="en-US" sz="1800" b="0" i="0" u="none" strike="noStrike" baseline="0" dirty="0" err="1">
                <a:latin typeface="CIDFont+F2"/>
              </a:rPr>
              <a:t>Kurst</a:t>
            </a:r>
            <a:r>
              <a:rPr lang="en-US" sz="1800" b="0" i="0" u="none" strike="noStrike" baseline="0" dirty="0">
                <a:latin typeface="CIDFont+F2"/>
              </a:rPr>
              <a:t> 2003). </a:t>
            </a:r>
            <a:endParaRPr lang="en-IE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0E4032C8-C43A-BA1B-953D-6A23D791DB4D}"/>
              </a:ext>
            </a:extLst>
          </p:cNvPr>
          <p:cNvSpPr txBox="1"/>
          <p:nvPr/>
        </p:nvSpPr>
        <p:spPr>
          <a:xfrm>
            <a:off x="460857" y="1036440"/>
            <a:ext cx="5193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/>
              <a:t>A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C5CBECC3-8D74-F062-663C-2BA1E358D6C7}"/>
              </a:ext>
            </a:extLst>
          </p:cNvPr>
          <p:cNvSpPr txBox="1"/>
          <p:nvPr/>
        </p:nvSpPr>
        <p:spPr>
          <a:xfrm>
            <a:off x="5305945" y="1101057"/>
            <a:ext cx="5193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E" dirty="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3209366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0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IDFont+F2</vt:lpstr>
      <vt:lpstr>fon3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Daniel Kerruish</dc:creator>
  <cp:lastModifiedBy>Daniel Kerruish</cp:lastModifiedBy>
  <cp:revision>4</cp:revision>
  <dcterms:created xsi:type="dcterms:W3CDTF">2024-12-12T07:10:35Z</dcterms:created>
  <dcterms:modified xsi:type="dcterms:W3CDTF">2025-01-17T13:48:55Z</dcterms:modified>
</cp:coreProperties>
</file>